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936F0E-4AAC-4723-B574-9934D2CC34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C0181F-444D-450C-A9ED-24EB6FDE7C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56E744-49DF-47A9-BB78-BD0580926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253F69-0A5F-4E78-80C0-ECAF12938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6E0B33-FDB2-47D3-8352-C1C5C918E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840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7CC22-BA59-424C-9A45-F10D620931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71FB0D-1E5C-45F6-B69D-D56F9485DA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250B60-1F6B-4038-98D1-07095DADD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DC3105-5DC1-4917-BFDE-3A76700D2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B176EA-80B8-4F96-B314-48D398636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52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4559856-E521-402A-AECF-5D2BCDEAFE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EA36CC-D1DC-4642-ADF0-DA6CE08F3B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EF8189-D0B5-4856-A92A-B12DC42B1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2CAB86-C905-4FC6-A704-142C67895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0C5280-2770-40C3-B760-26D39BA5F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871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A5259-84A6-4957-9A26-3642C11F4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C97075-7421-4EF6-881F-060B62B8D3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C8ABB9-1891-4952-A836-95984489B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1477C-EA85-492C-A86A-48F80CF65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49FD8F-5B52-41CD-96AA-67D1676F5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11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CD867-7710-4BFC-9268-4F854D000C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C2CFFB-0CC4-4975-A319-3B0676E51A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476E13-44DC-49E8-A47B-79FC2E640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95F4C8-FD08-4985-A651-BF52FD3B2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5145CC-1888-4EA7-A7FA-4773B0D84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524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EC016C-5681-4A35-9A27-87DDD2A0C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B42FCA-1CD6-49CD-A0C8-4A358D2215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75B5F6-914B-4CAA-8F76-A40E5C82B5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EA7B40-994E-4CC8-A1C2-C82FF5E04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2270A8-E7AF-4AC4-BF99-7904EB141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F42580-EEE4-4BEF-B8DE-AECA14B2F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399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DB605C-E225-416D-89D5-8630592C4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47886E-C8F8-47C2-B8E3-954C5EED54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995625-4997-4F27-93D2-DA8D00CC30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4183360-A3B3-4506-BBDD-C798F47E05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911E3C-2751-416A-A500-3690F18CF9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CCB47B-389B-499E-86D1-1677546BF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808F5F4-D564-42DC-A2A0-F29A31627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B8F7CB-66EE-4BDE-AF98-9716C8CB8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697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81D203-4B24-4251-BD86-A06E8018F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2F4413-4C7E-42E1-AD96-051A0CF60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C77BE1-2F7D-4637-B059-D8BA0B933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73941F-A2AF-4DD3-9F8A-7DEFB7F78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865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8196C8-ECAD-4DEF-944F-0C7CABD55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3A74FD7-FF85-4879-B336-8DA7A00BA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43EA12-83EB-4D16-AC55-5D9EDB3DF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775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0FD89-19EA-4990-8691-345FEC50CF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DD5F2-9C52-4F0B-BA0E-BA92E2278A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2C154-E06C-45F5-B75B-BC12B81080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13F0D4-9F24-4A89-A774-74082ADBD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47BF08-382D-44EF-B1E5-279D771496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3ECCB1-DB25-4C46-BE1E-D76E9734F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954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02FAE-DE07-4E6D-B5B1-2AFD1F5005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4C092D-F0F1-4EAD-9A9B-741EFFFE03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68EEBB-FA48-4823-87CE-DDA09BAEF0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B9CA4C-DB25-4A63-A180-9922BF97B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179EED-59BF-4686-B82F-B0EE18AED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92E38D-3036-4AA9-8D81-AFCEA74B0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70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A4931FA-A45B-45A0-8384-244E5B5CF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A87E3A-0E75-4220-92D6-C08BB09277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A6FB0F-2A95-4789-A7DD-D0E19A706A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DF3D7-7A90-4E9B-8817-45609FBE146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6B34A-D7BA-46F2-B095-135471F2BD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45D00D-C6E6-487B-8AF5-145406A0F0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2C093-57B4-4614-839F-D0AE856D88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717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B0091C0-A18F-4643-AD7F-3E7E7A1135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3813" y="209039"/>
            <a:ext cx="10397365" cy="577631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BF4EFE8-4E03-4390-8A52-22BACDCFA466}"/>
              </a:ext>
            </a:extLst>
          </p:cNvPr>
          <p:cNvSpPr txBox="1"/>
          <p:nvPr/>
        </p:nvSpPr>
        <p:spPr>
          <a:xfrm>
            <a:off x="377492" y="6076514"/>
            <a:ext cx="11437016" cy="64633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4: Correlation of TSPO </a:t>
            </a:r>
            <a:r>
              <a:rPr lang="en-US" sz="12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 Expression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sis with the Most Common Mutated Genes in GBM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ch graph includes the mutation status of each gene, wild-type (WT), mutated (MUT), or not applicable (N/A) for those patients who did not have DNA reads, using the TCGA-GBM dataset. CPM= counts per million. Kruskal-Wallis p-values are indicated in each graph.</a:t>
            </a:r>
          </a:p>
        </p:txBody>
      </p:sp>
    </p:spTree>
    <p:extLst>
      <p:ext uri="{BB962C8B-B14F-4D97-AF65-F5344CB8AC3E}">
        <p14:creationId xmlns:p14="http://schemas.microsoft.com/office/powerpoint/2010/main" val="129693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7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na Azzam</dc:creator>
  <cp:lastModifiedBy>Diana Azzam</cp:lastModifiedBy>
  <cp:revision>5</cp:revision>
  <dcterms:created xsi:type="dcterms:W3CDTF">2021-08-25T03:33:28Z</dcterms:created>
  <dcterms:modified xsi:type="dcterms:W3CDTF">2021-08-27T01:16:49Z</dcterms:modified>
</cp:coreProperties>
</file>